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gif" ContentType="image/gif"/>
  <Override PartName="/ppt/media/image2.gif" ContentType="image/gif"/>
  <Override PartName="/ppt/media/image3.gif" ContentType="image/gi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F2D93-2A79-42DE-A384-06EB74AB16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00FA1-5AC3-4A42-888F-349E1A8607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FE5C2-F132-4231-9818-FCD8D48F43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29E7F-F213-4D45-80FA-7BCC289F1E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131A5-F8DB-4727-84B8-2DBEF6B553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5BCBB-81E6-425C-81DA-CEE4F04B75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C2ADB5-45A0-4122-B746-266DCA6389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A8CC1-92B9-4D7D-84B2-A823D0829E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832E1-A416-467A-ABCD-44614A130C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7578E-111E-413C-918B-0348C68CA0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8BD85-971E-4105-ACBA-5A9EB7C149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842AE-9C15-493C-9AA8-CF8866448B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BE796F-342F-4FED-B65E-E81B466DD58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gi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gi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79280" y="620640"/>
            <a:ext cx="8678880" cy="5570640"/>
            <a:chOff x="179280" y="620640"/>
            <a:chExt cx="8678880" cy="55706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285840" y="666720"/>
              <a:ext cx="8572320" cy="552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79280" y="620640"/>
              <a:ext cx="5832720" cy="2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" name=""/>
          <p:cNvSpPr/>
          <p:nvPr/>
        </p:nvSpPr>
        <p:spPr>
          <a:xfrm>
            <a:off x="885960" y="281160"/>
            <a:ext cx="6813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800" spc="-1" strike="noStrike">
                <a:solidFill>
                  <a:srgbClr val="000000"/>
                </a:solidFill>
                <a:latin typeface="Arial"/>
              </a:rPr>
              <a:t>Atri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excitation (each frame false colour scaled to maximal value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"/>
          <p:cNvGrpSpPr/>
          <p:nvPr/>
        </p:nvGrpSpPr>
        <p:grpSpPr>
          <a:xfrm>
            <a:off x="179280" y="549360"/>
            <a:ext cx="8678880" cy="5641920"/>
            <a:chOff x="179280" y="549360"/>
            <a:chExt cx="8678880" cy="5641920"/>
          </a:xfrm>
        </p:grpSpPr>
        <p:pic>
          <p:nvPicPr>
            <p:cNvPr id="46" name="" descr=""/>
            <p:cNvPicPr/>
            <p:nvPr/>
          </p:nvPicPr>
          <p:blipFill>
            <a:blip r:embed="rId1"/>
            <a:stretch/>
          </p:blipFill>
          <p:spPr>
            <a:xfrm>
              <a:off x="285840" y="666720"/>
              <a:ext cx="8572320" cy="552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179280" y="549360"/>
              <a:ext cx="5761080" cy="287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886680" y="281160"/>
            <a:ext cx="728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800" spc="-1" strike="noStrike">
                <a:solidFill>
                  <a:srgbClr val="000000"/>
                </a:solidFill>
                <a:latin typeface="Arial"/>
              </a:rPr>
              <a:t>Atrial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excitation (all frame false colour scaled to overall maximal value</a:t>
            </a: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250920" y="620640"/>
            <a:ext cx="8607240" cy="5570640"/>
            <a:chOff x="250920" y="620640"/>
            <a:chExt cx="8607240" cy="5570640"/>
          </a:xfrm>
        </p:grpSpPr>
        <p:pic>
          <p:nvPicPr>
            <p:cNvPr id="50" name="" descr=""/>
            <p:cNvPicPr/>
            <p:nvPr/>
          </p:nvPicPr>
          <p:blipFill>
            <a:blip r:embed="rId1"/>
            <a:stretch/>
          </p:blipFill>
          <p:spPr>
            <a:xfrm>
              <a:off x="285840" y="666720"/>
              <a:ext cx="8572320" cy="552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250920" y="620640"/>
              <a:ext cx="5761080" cy="2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"/>
          <p:cNvSpPr/>
          <p:nvPr/>
        </p:nvSpPr>
        <p:spPr>
          <a:xfrm>
            <a:off x="886680" y="281160"/>
            <a:ext cx="7383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800" spc="-1" strike="noStrike">
                <a:solidFill>
                  <a:srgbClr val="000000"/>
                </a:solidFill>
                <a:latin typeface="Arial"/>
              </a:rPr>
              <a:t>Ventricular excitation (each frame false colour scaled to maximal valu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03T13:21:23Z</dcterms:created>
  <dc:creator>PTB Master Installation</dc:creator>
  <dc:description/>
  <dc:language>en-US</dc:language>
  <cp:lastModifiedBy>PTB Master Installation</cp:lastModifiedBy>
  <dcterms:modified xsi:type="dcterms:W3CDTF">2006-08-03T14:19:10Z</dcterms:modified>
  <cp:revision>4</cp:revision>
  <dc:subject/>
  <dc:title>Folie 1</dc:title>
</cp:coreProperties>
</file>